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60" r:id="rId3"/>
    <p:sldId id="256" r:id="rId4"/>
    <p:sldId id="259" r:id="rId5"/>
    <p:sldId id="257" r:id="rId6"/>
    <p:sldId id="266" r:id="rId7"/>
    <p:sldId id="267" r:id="rId8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99" autoAdjust="0"/>
    <p:restoredTop sz="94660"/>
  </p:normalViewPr>
  <p:slideViewPr>
    <p:cSldViewPr snapToGrid="0">
      <p:cViewPr varScale="1">
        <p:scale>
          <a:sx n="86" d="100"/>
          <a:sy n="86" d="100"/>
        </p:scale>
        <p:origin x="557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image" Target="../media/image3.emf"/><Relationship Id="rId5" Type="http://schemas.openxmlformats.org/officeDocument/2006/relationships/image" Target="../media/image7.emf"/><Relationship Id="rId4" Type="http://schemas.openxmlformats.org/officeDocument/2006/relationships/image" Target="../media/image6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image" Target="../media/image8.emf"/><Relationship Id="rId4" Type="http://schemas.openxmlformats.org/officeDocument/2006/relationships/image" Target="../media/image11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12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13.emf"/></Relationships>
</file>

<file path=ppt/drawings/_rels/vmlDrawing5.vml.rels><?xml version="1.0" encoding="UTF-8" standalone="yes"?>
<Relationships xmlns="http://schemas.openxmlformats.org/package/2006/relationships"><Relationship Id="rId8" Type="http://schemas.openxmlformats.org/officeDocument/2006/relationships/image" Target="../media/image21.emf"/><Relationship Id="rId3" Type="http://schemas.openxmlformats.org/officeDocument/2006/relationships/image" Target="../media/image16.emf"/><Relationship Id="rId7" Type="http://schemas.openxmlformats.org/officeDocument/2006/relationships/image" Target="../media/image20.emf"/><Relationship Id="rId2" Type="http://schemas.openxmlformats.org/officeDocument/2006/relationships/image" Target="../media/image15.emf"/><Relationship Id="rId1" Type="http://schemas.openxmlformats.org/officeDocument/2006/relationships/image" Target="../media/image14.emf"/><Relationship Id="rId6" Type="http://schemas.openxmlformats.org/officeDocument/2006/relationships/image" Target="../media/image19.emf"/><Relationship Id="rId5" Type="http://schemas.openxmlformats.org/officeDocument/2006/relationships/image" Target="../media/image18.emf"/><Relationship Id="rId4" Type="http://schemas.openxmlformats.org/officeDocument/2006/relationships/image" Target="../media/image17.emf"/><Relationship Id="rId9" Type="http://schemas.openxmlformats.org/officeDocument/2006/relationships/image" Target="../media/image22.emf"/></Relationships>
</file>

<file path=ppt/drawings/_rels/vmlDrawing6.vml.rels><?xml version="1.0" encoding="UTF-8" standalone="yes"?>
<Relationships xmlns="http://schemas.openxmlformats.org/package/2006/relationships"><Relationship Id="rId2" Type="http://schemas.openxmlformats.org/officeDocument/2006/relationships/image" Target="../media/image24.emf"/><Relationship Id="rId1" Type="http://schemas.openxmlformats.org/officeDocument/2006/relationships/image" Target="../media/image23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941D6C-82E8-4AAD-8D3C-BB930B3DD71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6DE9FAA-DAE7-4E09-B5B6-C47E1BF7205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EC89EB-04EA-4CC0-AFE1-9600E03734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7B36D-2EB2-42BA-A45D-C58AF6A1D533}" type="datetimeFigureOut">
              <a:rPr lang="en-US" smtClean="0"/>
              <a:t>6/3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92A2A2-C863-44A5-8F43-4A1BD86939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64CA8B-D12F-44B8-BF16-CF504B0FF2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F1D3C-2042-4FD6-B483-40335415E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40227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E9D06C-BCFE-4037-A140-E02A3422E9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604A108-7286-4C2A-8A36-89719833CCC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4B51A4-1855-4989-B30F-D888682B23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7B36D-2EB2-42BA-A45D-C58AF6A1D533}" type="datetimeFigureOut">
              <a:rPr lang="en-US" smtClean="0"/>
              <a:t>6/3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C4DCC7-3949-4CED-B4B6-2BF63B5825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C96BC6-C510-4077-90B2-FFAC4343A5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F1D3C-2042-4FD6-B483-40335415E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28371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CFFD0AF-9BE3-4DBB-BFCC-80BADF8A244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57B30BA-5824-46FA-8997-3E6C73CCC4A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EB7AB3-BF7F-400D-B1A3-C62935A2C9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7B36D-2EB2-42BA-A45D-C58AF6A1D533}" type="datetimeFigureOut">
              <a:rPr lang="en-US" smtClean="0"/>
              <a:t>6/3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812A4C-468A-476E-BCEA-E8601319A4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2EEC71-FBD5-4E93-8849-DFD2566643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F1D3C-2042-4FD6-B483-40335415E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8256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438299-4A90-4B48-BFF7-815E16B52D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9796108-4B60-4166-B00B-A3B4B227199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F4D682-D4F2-4EC7-94FB-D38A0DC935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7B36D-2EB2-42BA-A45D-C58AF6A1D533}" type="datetimeFigureOut">
              <a:rPr lang="en-US" smtClean="0"/>
              <a:t>6/3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0F1D91-DD49-4685-8202-7DCA743FCA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E641E5-1EAE-4CE4-8979-116E6E8296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F1D3C-2042-4FD6-B483-40335415E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51452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6A038F-0052-4893-AFE6-095B02B689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9C27F4A-0F7C-4ECA-864B-D22D798F0F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614DE0-EBF8-4349-8499-A56A4AA426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7B36D-2EB2-42BA-A45D-C58AF6A1D533}" type="datetimeFigureOut">
              <a:rPr lang="en-US" smtClean="0"/>
              <a:t>6/3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9A1F48-04CB-425F-BE10-1D8366F69B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075662-6A77-4A74-B0B1-8D365B03E8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F1D3C-2042-4FD6-B483-40335415E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24747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44F38A-4568-4E9E-98AD-ECA170A35C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ABF3033-AFD4-4575-8954-62AE00C426C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E6FE8F0-C09A-4C2D-8BC0-258719DC8D8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63AD4D2-D929-4879-8261-90762B2905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7B36D-2EB2-42BA-A45D-C58AF6A1D533}" type="datetimeFigureOut">
              <a:rPr lang="en-US" smtClean="0"/>
              <a:t>6/3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BAAD809-468E-4BF9-BB3F-E9734CB419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1B31CA2-AB4F-4F52-A7DD-FEF35E0EBC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F1D3C-2042-4FD6-B483-40335415E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37783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56F457-819F-4987-B4E8-2F695D8766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DB30ED3-51D7-4F28-85A5-C3145729DE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ECAA814-3EA9-42AE-AD52-EFBB32EDF67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FE03DEF-15FA-4AFB-95BF-A16ABC0DDA1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961F167-5EF8-4608-9274-D4F3AD78BC7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004C5A0-A7F4-4B3B-BDAF-708D19ABA3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7B36D-2EB2-42BA-A45D-C58AF6A1D533}" type="datetimeFigureOut">
              <a:rPr lang="en-US" smtClean="0"/>
              <a:t>6/3/20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CA17F4F-52A5-473B-9EA6-5814E96EDD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B345B26-4C90-495B-AB23-345D9A4AE1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F1D3C-2042-4FD6-B483-40335415E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17682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FC9199-AE3A-44EF-B209-262F31314B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8D5DDE2-0C17-41C9-9F1B-B7898641E5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7B36D-2EB2-42BA-A45D-C58AF6A1D533}" type="datetimeFigureOut">
              <a:rPr lang="en-US" smtClean="0"/>
              <a:t>6/3/20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93B7D21-B6A2-4C65-AC11-6E435CC416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1E9D438-DA88-41E2-A5AA-B7BFD9A363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F1D3C-2042-4FD6-B483-40335415E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16383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A2C343E-9E52-4337-8130-5558AD7004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7B36D-2EB2-42BA-A45D-C58AF6A1D533}" type="datetimeFigureOut">
              <a:rPr lang="en-US" smtClean="0"/>
              <a:t>6/3/20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E6DD4DB-8591-4218-8AB3-7892B65E5E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56D519B-2ABB-460B-96AB-439B798002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F1D3C-2042-4FD6-B483-40335415E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31851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C8A1C8-4F0B-4D73-8220-035B3C7BB3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21F6DEC-B194-4A8A-A0E0-7A5D7C96CF9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514DFB1-8C2E-4268-A9EE-F6B394A8EF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9CABE24-98CB-4F22-B52C-496D02C19D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7B36D-2EB2-42BA-A45D-C58AF6A1D533}" type="datetimeFigureOut">
              <a:rPr lang="en-US" smtClean="0"/>
              <a:t>6/3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9F3DFAE-6C72-498D-A45B-A3965504E3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4887BCB-9485-41EA-89F9-C77B654DC8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F1D3C-2042-4FD6-B483-40335415E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05950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8064EF-1233-4B49-9A0B-6AA908C500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0E69A8F-E4D2-4A67-B773-75F3A1E47FD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F010BF7-1F32-4E09-9DE2-2C5C211B885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F395BE3-8025-4CC0-8AA6-40B0E1755E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7B36D-2EB2-42BA-A45D-C58AF6A1D533}" type="datetimeFigureOut">
              <a:rPr lang="en-US" smtClean="0"/>
              <a:t>6/3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D03CEFA-1966-4EFD-A4F4-56C31917D2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E6B0CC7-42C6-469A-852C-C04470A181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F1D3C-2042-4FD6-B483-40335415E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72844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17E3DAD-416C-4C6F-94D1-532A51BA80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4B2CC3F-DDD3-4738-B4B4-8B40331834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CB92F7-5B39-4DB5-A9E0-FC02FD6BDDB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27B36D-2EB2-42BA-A45D-C58AF6A1D533}" type="datetimeFigureOut">
              <a:rPr lang="en-US" smtClean="0"/>
              <a:t>6/3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B8A0BC-980C-497C-90D3-FFAFECA5FB2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1B8F8C-692A-4FC8-8A70-9B467F1EB6D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0F1D3C-2042-4FD6-B483-40335415E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08389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7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4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6.emf"/><Relationship Id="rId4" Type="http://schemas.openxmlformats.org/officeDocument/2006/relationships/image" Target="../media/image3.emf"/><Relationship Id="rId9" Type="http://schemas.openxmlformats.org/officeDocument/2006/relationships/oleObject" Target="../embeddings/oleObject4.bin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emf"/><Relationship Id="rId3" Type="http://schemas.openxmlformats.org/officeDocument/2006/relationships/oleObject" Target="../embeddings/oleObject6.bin"/><Relationship Id="rId7" Type="http://schemas.openxmlformats.org/officeDocument/2006/relationships/oleObject" Target="../embeddings/oleObject8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9.emf"/><Relationship Id="rId5" Type="http://schemas.openxmlformats.org/officeDocument/2006/relationships/oleObject" Target="../embeddings/oleObject7.bin"/><Relationship Id="rId10" Type="http://schemas.openxmlformats.org/officeDocument/2006/relationships/image" Target="../media/image11.emf"/><Relationship Id="rId4" Type="http://schemas.openxmlformats.org/officeDocument/2006/relationships/image" Target="../media/image8.emf"/><Relationship Id="rId9" Type="http://schemas.openxmlformats.org/officeDocument/2006/relationships/oleObject" Target="../embeddings/oleObject9.bin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0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4" Type="http://schemas.openxmlformats.org/officeDocument/2006/relationships/image" Target="../media/image12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4.vml"/><Relationship Id="rId4" Type="http://schemas.openxmlformats.org/officeDocument/2006/relationships/image" Target="../media/image13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emf"/><Relationship Id="rId13" Type="http://schemas.openxmlformats.org/officeDocument/2006/relationships/oleObject" Target="../embeddings/oleObject17.bin"/><Relationship Id="rId18" Type="http://schemas.openxmlformats.org/officeDocument/2006/relationships/image" Target="../media/image21.emf"/><Relationship Id="rId3" Type="http://schemas.openxmlformats.org/officeDocument/2006/relationships/oleObject" Target="../embeddings/oleObject12.bin"/><Relationship Id="rId7" Type="http://schemas.openxmlformats.org/officeDocument/2006/relationships/oleObject" Target="../embeddings/oleObject14.bin"/><Relationship Id="rId12" Type="http://schemas.openxmlformats.org/officeDocument/2006/relationships/image" Target="../media/image18.emf"/><Relationship Id="rId17" Type="http://schemas.openxmlformats.org/officeDocument/2006/relationships/oleObject" Target="../embeddings/oleObject19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20.emf"/><Relationship Id="rId20" Type="http://schemas.openxmlformats.org/officeDocument/2006/relationships/image" Target="../media/image22.emf"/><Relationship Id="rId1" Type="http://schemas.openxmlformats.org/officeDocument/2006/relationships/vmlDrawing" Target="../drawings/vmlDrawing5.vml"/><Relationship Id="rId6" Type="http://schemas.openxmlformats.org/officeDocument/2006/relationships/image" Target="../media/image15.emf"/><Relationship Id="rId11" Type="http://schemas.openxmlformats.org/officeDocument/2006/relationships/oleObject" Target="../embeddings/oleObject16.bin"/><Relationship Id="rId5" Type="http://schemas.openxmlformats.org/officeDocument/2006/relationships/oleObject" Target="../embeddings/oleObject13.bin"/><Relationship Id="rId15" Type="http://schemas.openxmlformats.org/officeDocument/2006/relationships/oleObject" Target="../embeddings/oleObject18.bin"/><Relationship Id="rId10" Type="http://schemas.openxmlformats.org/officeDocument/2006/relationships/image" Target="../media/image17.emf"/><Relationship Id="rId19" Type="http://schemas.openxmlformats.org/officeDocument/2006/relationships/oleObject" Target="../embeddings/oleObject20.bin"/><Relationship Id="rId4" Type="http://schemas.openxmlformats.org/officeDocument/2006/relationships/image" Target="../media/image14.emf"/><Relationship Id="rId9" Type="http://schemas.openxmlformats.org/officeDocument/2006/relationships/oleObject" Target="../embeddings/oleObject15.bin"/><Relationship Id="rId14" Type="http://schemas.openxmlformats.org/officeDocument/2006/relationships/image" Target="../media/image19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6.vml"/><Relationship Id="rId6" Type="http://schemas.openxmlformats.org/officeDocument/2006/relationships/image" Target="../media/image24.emf"/><Relationship Id="rId5" Type="http://schemas.openxmlformats.org/officeDocument/2006/relationships/oleObject" Target="../embeddings/oleObject22.bin"/><Relationship Id="rId4" Type="http://schemas.openxmlformats.org/officeDocument/2006/relationships/image" Target="../media/image2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" name="Picture 34">
            <a:extLst>
              <a:ext uri="{FF2B5EF4-FFF2-40B4-BE49-F238E27FC236}">
                <a16:creationId xmlns:a16="http://schemas.microsoft.com/office/drawing/2014/main" id="{CA2F5510-6105-4A1C-ABEC-9B9B82336D1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/>
          </a:blip>
          <a:stretch>
            <a:fillRect/>
          </a:stretch>
        </p:blipFill>
        <p:spPr>
          <a:xfrm>
            <a:off x="736850" y="989698"/>
            <a:ext cx="4309771" cy="5571805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15E84748-DF4B-4C2F-9700-B7E41DFE50A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/>
          </a:blip>
          <a:stretch>
            <a:fillRect/>
          </a:stretch>
        </p:blipFill>
        <p:spPr>
          <a:xfrm>
            <a:off x="6318273" y="989698"/>
            <a:ext cx="4654527" cy="5571805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D0DFC3FB-D860-40AB-9E75-E036EE483D04}"/>
              </a:ext>
            </a:extLst>
          </p:cNvPr>
          <p:cNvSpPr txBox="1"/>
          <p:nvPr/>
        </p:nvSpPr>
        <p:spPr>
          <a:xfrm>
            <a:off x="1087517" y="6376099"/>
            <a:ext cx="7812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(A)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1BDAF754-1C3B-48CC-93F6-A5150004448F}"/>
              </a:ext>
            </a:extLst>
          </p:cNvPr>
          <p:cNvSpPr txBox="1"/>
          <p:nvPr/>
        </p:nvSpPr>
        <p:spPr>
          <a:xfrm>
            <a:off x="6612089" y="6366936"/>
            <a:ext cx="7812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(B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33E4947-B2DF-471B-A5F8-0152AEB40DB2}"/>
              </a:ext>
            </a:extLst>
          </p:cNvPr>
          <p:cNvSpPr txBox="1"/>
          <p:nvPr/>
        </p:nvSpPr>
        <p:spPr>
          <a:xfrm>
            <a:off x="59026" y="45607"/>
            <a:ext cx="26397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468F2EA-A145-4414-9C1A-10B4F28E6B52}"/>
              </a:ext>
            </a:extLst>
          </p:cNvPr>
          <p:cNvSpPr txBox="1"/>
          <p:nvPr/>
        </p:nvSpPr>
        <p:spPr>
          <a:xfrm>
            <a:off x="1970839" y="639164"/>
            <a:ext cx="23880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NPs on Chromosome 8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5762F29-6890-4D11-BF71-7786542C9E80}"/>
              </a:ext>
            </a:extLst>
          </p:cNvPr>
          <p:cNvSpPr txBox="1"/>
          <p:nvPr/>
        </p:nvSpPr>
        <p:spPr>
          <a:xfrm>
            <a:off x="7733928" y="639164"/>
            <a:ext cx="23880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NPs on Chromosome 11</a:t>
            </a:r>
          </a:p>
        </p:txBody>
      </p:sp>
    </p:spTree>
    <p:extLst>
      <p:ext uri="{BB962C8B-B14F-4D97-AF65-F5344CB8AC3E}">
        <p14:creationId xmlns:p14="http://schemas.microsoft.com/office/powerpoint/2010/main" val="139930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04C74E3A-B268-461C-95CD-4CD469257D4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45631602"/>
              </p:ext>
            </p:extLst>
          </p:nvPr>
        </p:nvGraphicFramePr>
        <p:xfrm>
          <a:off x="5310188" y="3530600"/>
          <a:ext cx="6162675" cy="3479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96" name="Prism 7" r:id="rId3" imgW="7538163" imgH="4256186" progId="Prism7.Document">
                  <p:embed/>
                </p:oleObj>
              </mc:Choice>
              <mc:Fallback>
                <p:oleObj name="Prism 7" r:id="rId3" imgW="7538163" imgH="4256186" progId="Prism7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04C74E3A-B268-461C-95CD-4CD469257D4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310188" y="3530600"/>
                        <a:ext cx="6162675" cy="3479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36E741DE-77A1-4657-8DEE-8B7FB8EFD18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9659278"/>
              </p:ext>
            </p:extLst>
          </p:nvPr>
        </p:nvGraphicFramePr>
        <p:xfrm>
          <a:off x="196850" y="528638"/>
          <a:ext cx="3381375" cy="29479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97" name="Prism 7" r:id="rId5" imgW="4716121" imgH="4111482" progId="Prism7.Document">
                  <p:embed/>
                </p:oleObj>
              </mc:Choice>
              <mc:Fallback>
                <p:oleObj name="Prism 7" r:id="rId5" imgW="4716121" imgH="4111482" progId="Prism7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36E741DE-77A1-4657-8DEE-8B7FB8EFD18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96850" y="528638"/>
                        <a:ext cx="3381375" cy="29479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206BA913-F8C8-402F-ADC3-790CF420CE0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5253272"/>
              </p:ext>
            </p:extLst>
          </p:nvPr>
        </p:nvGraphicFramePr>
        <p:xfrm>
          <a:off x="8275638" y="528638"/>
          <a:ext cx="3378200" cy="2943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98" name="Prism 7" r:id="rId7" imgW="4716121" imgH="4111482" progId="Prism7.Document">
                  <p:embed/>
                </p:oleObj>
              </mc:Choice>
              <mc:Fallback>
                <p:oleObj name="Prism 7" r:id="rId7" imgW="4716121" imgH="4111482" progId="Prism7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206BA913-F8C8-402F-ADC3-790CF420CE0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8275638" y="528638"/>
                        <a:ext cx="3378200" cy="2943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6B61C477-DA67-45E7-B7BB-F8917DA62C9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70995928"/>
              </p:ext>
            </p:extLst>
          </p:nvPr>
        </p:nvGraphicFramePr>
        <p:xfrm>
          <a:off x="315097" y="3638704"/>
          <a:ext cx="4214021" cy="327269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99" name="Prism 7" r:id="rId9" imgW="7021628" imgH="5444779" progId="Prism7.Document">
                  <p:embed/>
                </p:oleObj>
              </mc:Choice>
              <mc:Fallback>
                <p:oleObj name="Prism 7" r:id="rId9" imgW="7021628" imgH="5444779" progId="Prism7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6B61C477-DA67-45E7-B7BB-F8917DA62C9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15097" y="3638704"/>
                        <a:ext cx="4214021" cy="327269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8D747DE7-B47B-41DB-9183-94975DC6BF9B}"/>
              </a:ext>
            </a:extLst>
          </p:cNvPr>
          <p:cNvSpPr txBox="1"/>
          <p:nvPr/>
        </p:nvSpPr>
        <p:spPr>
          <a:xfrm>
            <a:off x="1548970" y="929540"/>
            <a:ext cx="9991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/>
              <a:t>p= </a:t>
            </a:r>
            <a:r>
              <a:rPr lang="en-US" dirty="0"/>
              <a:t>0.2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2CC6CE2-7079-41EC-9854-63E2B3CD138C}"/>
              </a:ext>
            </a:extLst>
          </p:cNvPr>
          <p:cNvSpPr txBox="1"/>
          <p:nvPr/>
        </p:nvSpPr>
        <p:spPr>
          <a:xfrm>
            <a:off x="10522290" y="1159985"/>
            <a:ext cx="9991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/>
              <a:t>p= </a:t>
            </a:r>
            <a:r>
              <a:rPr lang="en-US" dirty="0"/>
              <a:t>0.32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AC39166-439E-4DF8-8B3A-03E229D7E02C}"/>
              </a:ext>
            </a:extLst>
          </p:cNvPr>
          <p:cNvSpPr txBox="1"/>
          <p:nvPr/>
        </p:nvSpPr>
        <p:spPr>
          <a:xfrm>
            <a:off x="1608278" y="4006518"/>
            <a:ext cx="9991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/>
              <a:t>p= </a:t>
            </a:r>
            <a:r>
              <a:rPr lang="en-US" dirty="0"/>
              <a:t>0.27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6BCD21A-EBD8-4070-B3B6-691BE05857FC}"/>
              </a:ext>
            </a:extLst>
          </p:cNvPr>
          <p:cNvSpPr txBox="1"/>
          <p:nvPr/>
        </p:nvSpPr>
        <p:spPr>
          <a:xfrm>
            <a:off x="6567604" y="4189193"/>
            <a:ext cx="9991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/>
              <a:t>p= </a:t>
            </a:r>
            <a:r>
              <a:rPr lang="en-US" dirty="0"/>
              <a:t>0.09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643D9CAD-1583-4C19-ACB5-7547ACD3F644}"/>
              </a:ext>
            </a:extLst>
          </p:cNvPr>
          <p:cNvSpPr/>
          <p:nvPr/>
        </p:nvSpPr>
        <p:spPr>
          <a:xfrm rot="2702339">
            <a:off x="1396441" y="2400877"/>
            <a:ext cx="399239" cy="950851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448204B3-CC18-45A1-8172-4B697A77ED3A}"/>
              </a:ext>
            </a:extLst>
          </p:cNvPr>
          <p:cNvSpPr/>
          <p:nvPr/>
        </p:nvSpPr>
        <p:spPr>
          <a:xfrm rot="2702339">
            <a:off x="9483922" y="2394672"/>
            <a:ext cx="392045" cy="950851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9FCA9F44-EEC0-416D-AA6F-567071317A77}"/>
              </a:ext>
            </a:extLst>
          </p:cNvPr>
          <p:cNvSpPr/>
          <p:nvPr/>
        </p:nvSpPr>
        <p:spPr>
          <a:xfrm rot="2702339">
            <a:off x="1799143" y="5910860"/>
            <a:ext cx="369749" cy="950851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71084FF3-B012-4FB9-AD9B-E191DB3604B7}"/>
              </a:ext>
            </a:extLst>
          </p:cNvPr>
          <p:cNvSpPr/>
          <p:nvPr/>
        </p:nvSpPr>
        <p:spPr>
          <a:xfrm rot="5400000">
            <a:off x="10528319" y="3336340"/>
            <a:ext cx="179132" cy="1526577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21" name="Object 20">
            <a:extLst>
              <a:ext uri="{FF2B5EF4-FFF2-40B4-BE49-F238E27FC236}">
                <a16:creationId xmlns:a16="http://schemas.microsoft.com/office/drawing/2014/main" id="{67DA005F-A44E-42E6-8FDA-E0368478DA6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27718869"/>
              </p:ext>
            </p:extLst>
          </p:nvPr>
        </p:nvGraphicFramePr>
        <p:xfrm>
          <a:off x="4310063" y="531813"/>
          <a:ext cx="3378200" cy="2943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00" name="Prism 7" r:id="rId11" imgW="4716121" imgH="4111482" progId="Prism7.Document">
                  <p:embed/>
                </p:oleObj>
              </mc:Choice>
              <mc:Fallback>
                <p:oleObj name="Prism 7" r:id="rId11" imgW="4716121" imgH="4111482" progId="Prism7.Document">
                  <p:embed/>
                  <p:pic>
                    <p:nvPicPr>
                      <p:cNvPr id="21" name="Object 20">
                        <a:extLst>
                          <a:ext uri="{FF2B5EF4-FFF2-40B4-BE49-F238E27FC236}">
                            <a16:creationId xmlns:a16="http://schemas.microsoft.com/office/drawing/2014/main" id="{67DA005F-A44E-42E6-8FDA-E0368478DA6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310063" y="531813"/>
                        <a:ext cx="3378200" cy="2943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2" name="TextBox 21">
            <a:extLst>
              <a:ext uri="{FF2B5EF4-FFF2-40B4-BE49-F238E27FC236}">
                <a16:creationId xmlns:a16="http://schemas.microsoft.com/office/drawing/2014/main" id="{28CBAA6C-3EE2-49FC-8725-EE8738750156}"/>
              </a:ext>
            </a:extLst>
          </p:cNvPr>
          <p:cNvSpPr txBox="1"/>
          <p:nvPr/>
        </p:nvSpPr>
        <p:spPr>
          <a:xfrm>
            <a:off x="6452841" y="928051"/>
            <a:ext cx="9991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/>
              <a:t>p= </a:t>
            </a:r>
            <a:r>
              <a:rPr lang="en-US" dirty="0"/>
              <a:t>0.25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8DF73FA4-DA6A-45C6-8E98-1E212975AC54}"/>
              </a:ext>
            </a:extLst>
          </p:cNvPr>
          <p:cNvSpPr/>
          <p:nvPr/>
        </p:nvSpPr>
        <p:spPr>
          <a:xfrm rot="2702339">
            <a:off x="5510054" y="2414136"/>
            <a:ext cx="415830" cy="950851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B87A5B9-3A94-490C-B7DA-D6C27B42A644}"/>
              </a:ext>
            </a:extLst>
          </p:cNvPr>
          <p:cNvSpPr txBox="1"/>
          <p:nvPr/>
        </p:nvSpPr>
        <p:spPr>
          <a:xfrm>
            <a:off x="1118599" y="4558525"/>
            <a:ext cx="631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n=9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625560C-4A98-4A32-BEE8-FCDEE10AC64C}"/>
              </a:ext>
            </a:extLst>
          </p:cNvPr>
          <p:cNvSpPr txBox="1"/>
          <p:nvPr/>
        </p:nvSpPr>
        <p:spPr>
          <a:xfrm>
            <a:off x="1074501" y="5547537"/>
            <a:ext cx="6998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n=11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F2EEBBB2-230F-45B0-B211-9A82DA7275F5}"/>
              </a:ext>
            </a:extLst>
          </p:cNvPr>
          <p:cNvSpPr txBox="1"/>
          <p:nvPr/>
        </p:nvSpPr>
        <p:spPr>
          <a:xfrm>
            <a:off x="2796818" y="4558525"/>
            <a:ext cx="631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n=9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7503F63D-A25A-4E7F-822A-5F6B68B02881}"/>
              </a:ext>
            </a:extLst>
          </p:cNvPr>
          <p:cNvSpPr txBox="1"/>
          <p:nvPr/>
        </p:nvSpPr>
        <p:spPr>
          <a:xfrm>
            <a:off x="3599060" y="4558525"/>
            <a:ext cx="6701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n=15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E532288D-3722-44C9-88EE-D0367854F15B}"/>
              </a:ext>
            </a:extLst>
          </p:cNvPr>
          <p:cNvSpPr txBox="1"/>
          <p:nvPr/>
        </p:nvSpPr>
        <p:spPr>
          <a:xfrm>
            <a:off x="1936447" y="4558525"/>
            <a:ext cx="631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n=4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9454C6FB-4B63-4C9B-8C06-24732EE612EA}"/>
              </a:ext>
            </a:extLst>
          </p:cNvPr>
          <p:cNvSpPr txBox="1"/>
          <p:nvPr/>
        </p:nvSpPr>
        <p:spPr>
          <a:xfrm>
            <a:off x="1946017" y="5547537"/>
            <a:ext cx="631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n=4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0B2C1C4A-43DA-4970-B628-5645E3B76FDF}"/>
              </a:ext>
            </a:extLst>
          </p:cNvPr>
          <p:cNvSpPr txBox="1"/>
          <p:nvPr/>
        </p:nvSpPr>
        <p:spPr>
          <a:xfrm>
            <a:off x="2778469" y="5547537"/>
            <a:ext cx="631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n=3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28BDD9D-B460-46B8-9009-715C5BB46454}"/>
              </a:ext>
            </a:extLst>
          </p:cNvPr>
          <p:cNvSpPr txBox="1"/>
          <p:nvPr/>
        </p:nvSpPr>
        <p:spPr>
          <a:xfrm>
            <a:off x="3657668" y="5547537"/>
            <a:ext cx="631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n=7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40980B6C-659B-404F-BE81-3EC50D8D5E6C}"/>
              </a:ext>
            </a:extLst>
          </p:cNvPr>
          <p:cNvSpPr txBox="1"/>
          <p:nvPr/>
        </p:nvSpPr>
        <p:spPr>
          <a:xfrm>
            <a:off x="131671" y="2317072"/>
            <a:ext cx="5824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(A)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B9D022D-1AE4-44C0-8B64-0D81D4A2202C}"/>
              </a:ext>
            </a:extLst>
          </p:cNvPr>
          <p:cNvSpPr txBox="1"/>
          <p:nvPr/>
        </p:nvSpPr>
        <p:spPr>
          <a:xfrm>
            <a:off x="4266350" y="2312702"/>
            <a:ext cx="55409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(B)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D6991E4B-AF8D-4B8C-9027-61E2420AD81C}"/>
              </a:ext>
            </a:extLst>
          </p:cNvPr>
          <p:cNvSpPr txBox="1"/>
          <p:nvPr/>
        </p:nvSpPr>
        <p:spPr>
          <a:xfrm>
            <a:off x="8282769" y="2321580"/>
            <a:ext cx="5624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(C)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ADBA28F3-F9A5-4080-92D9-C5D196176CAA}"/>
              </a:ext>
            </a:extLst>
          </p:cNvPr>
          <p:cNvSpPr txBox="1"/>
          <p:nvPr/>
        </p:nvSpPr>
        <p:spPr>
          <a:xfrm>
            <a:off x="84770" y="5870695"/>
            <a:ext cx="5824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(D)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CCF11A7-A7CC-4303-94DF-08048C8CE56C}"/>
              </a:ext>
            </a:extLst>
          </p:cNvPr>
          <p:cNvSpPr txBox="1"/>
          <p:nvPr/>
        </p:nvSpPr>
        <p:spPr>
          <a:xfrm>
            <a:off x="5294147" y="5897329"/>
            <a:ext cx="59631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(E)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E8FCC76F-A6AA-4F51-99F0-72AFD276923D}"/>
              </a:ext>
            </a:extLst>
          </p:cNvPr>
          <p:cNvSpPr txBox="1"/>
          <p:nvPr/>
        </p:nvSpPr>
        <p:spPr>
          <a:xfrm>
            <a:off x="59026" y="45607"/>
            <a:ext cx="26397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FC54C20-F7EA-4F7E-8DF2-28D43C84E20E}"/>
              </a:ext>
            </a:extLst>
          </p:cNvPr>
          <p:cNvSpPr txBox="1"/>
          <p:nvPr/>
        </p:nvSpPr>
        <p:spPr>
          <a:xfrm rot="19070236">
            <a:off x="778060" y="2541219"/>
            <a:ext cx="8550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=20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3002622A-A20E-4F60-BB44-4AD701F39178}"/>
              </a:ext>
            </a:extLst>
          </p:cNvPr>
          <p:cNvSpPr txBox="1"/>
          <p:nvPr/>
        </p:nvSpPr>
        <p:spPr>
          <a:xfrm rot="18975955">
            <a:off x="1436491" y="2622595"/>
            <a:ext cx="8550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=8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61042238-75EA-4E95-9EAE-8F65B44B56CD}"/>
              </a:ext>
            </a:extLst>
          </p:cNvPr>
          <p:cNvSpPr txBox="1"/>
          <p:nvPr/>
        </p:nvSpPr>
        <p:spPr>
          <a:xfrm rot="18975955">
            <a:off x="1958909" y="2635262"/>
            <a:ext cx="8550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=12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E419EAA3-E11D-4994-9726-9FB77C2CA032}"/>
              </a:ext>
            </a:extLst>
          </p:cNvPr>
          <p:cNvSpPr txBox="1"/>
          <p:nvPr/>
        </p:nvSpPr>
        <p:spPr>
          <a:xfrm rot="18975955">
            <a:off x="2545653" y="2677889"/>
            <a:ext cx="8550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=22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E139C776-40F1-4916-B054-E81FD42032D9}"/>
              </a:ext>
            </a:extLst>
          </p:cNvPr>
          <p:cNvSpPr txBox="1"/>
          <p:nvPr/>
        </p:nvSpPr>
        <p:spPr>
          <a:xfrm rot="19070236">
            <a:off x="4924986" y="2515714"/>
            <a:ext cx="8550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=20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3950D24D-E16D-40BD-86B1-7C34A3C20313}"/>
              </a:ext>
            </a:extLst>
          </p:cNvPr>
          <p:cNvSpPr txBox="1"/>
          <p:nvPr/>
        </p:nvSpPr>
        <p:spPr>
          <a:xfrm rot="18975955">
            <a:off x="5583417" y="2597090"/>
            <a:ext cx="8550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=8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7069EDEF-AA20-47BB-9FC5-7161C0E0E668}"/>
              </a:ext>
            </a:extLst>
          </p:cNvPr>
          <p:cNvSpPr txBox="1"/>
          <p:nvPr/>
        </p:nvSpPr>
        <p:spPr>
          <a:xfrm rot="18975955">
            <a:off x="6105835" y="2609757"/>
            <a:ext cx="8550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=12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2B2DCEBB-3CE2-4D51-99B4-39DF97DD9D55}"/>
              </a:ext>
            </a:extLst>
          </p:cNvPr>
          <p:cNvSpPr txBox="1"/>
          <p:nvPr/>
        </p:nvSpPr>
        <p:spPr>
          <a:xfrm rot="18975955">
            <a:off x="6692579" y="2652384"/>
            <a:ext cx="8550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=22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5213AEFE-BB6D-4C76-90FD-48893DD2A328}"/>
              </a:ext>
            </a:extLst>
          </p:cNvPr>
          <p:cNvSpPr txBox="1"/>
          <p:nvPr/>
        </p:nvSpPr>
        <p:spPr>
          <a:xfrm rot="19070236">
            <a:off x="8859282" y="2534946"/>
            <a:ext cx="8550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=20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2F39F43C-03A5-4990-B829-A181C495AAA4}"/>
              </a:ext>
            </a:extLst>
          </p:cNvPr>
          <p:cNvSpPr txBox="1"/>
          <p:nvPr/>
        </p:nvSpPr>
        <p:spPr>
          <a:xfrm rot="18975955">
            <a:off x="9517713" y="2616322"/>
            <a:ext cx="8550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=8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C39F1E30-DC2F-43F4-8737-0D9FCB0C9575}"/>
              </a:ext>
            </a:extLst>
          </p:cNvPr>
          <p:cNvSpPr txBox="1"/>
          <p:nvPr/>
        </p:nvSpPr>
        <p:spPr>
          <a:xfrm rot="18975955">
            <a:off x="10040131" y="2628989"/>
            <a:ext cx="8550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=12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9689C92F-69C1-4594-BC6D-1B60F8A7EA32}"/>
              </a:ext>
            </a:extLst>
          </p:cNvPr>
          <p:cNvSpPr txBox="1"/>
          <p:nvPr/>
        </p:nvSpPr>
        <p:spPr>
          <a:xfrm rot="18975955">
            <a:off x="10626875" y="2671616"/>
            <a:ext cx="8550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=22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557DA842-2D49-4F8C-BE32-336D0CFA360E}"/>
              </a:ext>
            </a:extLst>
          </p:cNvPr>
          <p:cNvSpPr txBox="1"/>
          <p:nvPr/>
        </p:nvSpPr>
        <p:spPr>
          <a:xfrm rot="19070236">
            <a:off x="993648" y="6041634"/>
            <a:ext cx="8550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=20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1AAAD2B5-FE63-4DEF-9020-248545A6674C}"/>
              </a:ext>
            </a:extLst>
          </p:cNvPr>
          <p:cNvSpPr txBox="1"/>
          <p:nvPr/>
        </p:nvSpPr>
        <p:spPr>
          <a:xfrm rot="18975955">
            <a:off x="1811875" y="6149643"/>
            <a:ext cx="8550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=8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CF901584-9039-474A-AC5C-86B1208D8851}"/>
              </a:ext>
            </a:extLst>
          </p:cNvPr>
          <p:cNvSpPr txBox="1"/>
          <p:nvPr/>
        </p:nvSpPr>
        <p:spPr>
          <a:xfrm rot="18975955">
            <a:off x="2627262" y="6082409"/>
            <a:ext cx="8550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=12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2BFE0EFD-64B6-44EF-AC3E-512702682251}"/>
              </a:ext>
            </a:extLst>
          </p:cNvPr>
          <p:cNvSpPr txBox="1"/>
          <p:nvPr/>
        </p:nvSpPr>
        <p:spPr>
          <a:xfrm rot="18975955">
            <a:off x="3444826" y="6107281"/>
            <a:ext cx="8550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=22</a:t>
            </a:r>
          </a:p>
        </p:txBody>
      </p:sp>
    </p:spTree>
    <p:extLst>
      <p:ext uri="{BB962C8B-B14F-4D97-AF65-F5344CB8AC3E}">
        <p14:creationId xmlns:p14="http://schemas.microsoft.com/office/powerpoint/2010/main" val="34181956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BAEC6065-B6B7-4683-9396-132CF2FA9B6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85812003"/>
              </p:ext>
            </p:extLst>
          </p:nvPr>
        </p:nvGraphicFramePr>
        <p:xfrm>
          <a:off x="7274558" y="720045"/>
          <a:ext cx="3371850" cy="2689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38" name="Prism 7" r:id="rId3" imgW="3827754" imgH="3052115" progId="Prism7.Document">
                  <p:embed/>
                </p:oleObj>
              </mc:Choice>
              <mc:Fallback>
                <p:oleObj name="Prism 7" r:id="rId3" imgW="3827754" imgH="3052115" progId="Prism7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BAEC6065-B6B7-4683-9396-132CF2FA9B6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274558" y="720045"/>
                        <a:ext cx="3371850" cy="2689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5E00D58C-E174-4013-9DBE-4AC6ACA63D1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70916930"/>
              </p:ext>
            </p:extLst>
          </p:nvPr>
        </p:nvGraphicFramePr>
        <p:xfrm>
          <a:off x="1612452" y="4065507"/>
          <a:ext cx="3373438" cy="26908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39" name="Prism 7" r:id="rId5" imgW="3827754" imgH="3052115" progId="Prism7.Document">
                  <p:embed/>
                </p:oleObj>
              </mc:Choice>
              <mc:Fallback>
                <p:oleObj name="Prism 7" r:id="rId5" imgW="3827754" imgH="3052115" progId="Prism7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5E00D58C-E174-4013-9DBE-4AC6ACA63D1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612452" y="4065507"/>
                        <a:ext cx="3373438" cy="26908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7A0F4C69-BB62-441A-B1F6-6E1B1F69796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48858860"/>
              </p:ext>
            </p:extLst>
          </p:nvPr>
        </p:nvGraphicFramePr>
        <p:xfrm>
          <a:off x="7043384" y="3670240"/>
          <a:ext cx="3868737" cy="3067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40" name="Prism 7" r:id="rId7" imgW="4574299" imgH="3623734" progId="Prism7.Document">
                  <p:embed/>
                </p:oleObj>
              </mc:Choice>
              <mc:Fallback>
                <p:oleObj name="Prism 7" r:id="rId7" imgW="4574299" imgH="3623734" progId="Prism7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7A0F4C69-BB62-441A-B1F6-6E1B1F69796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7043384" y="3670240"/>
                        <a:ext cx="3868737" cy="30670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id="{D45053DF-385E-4ADC-83FA-CA72053532DF}"/>
              </a:ext>
            </a:extLst>
          </p:cNvPr>
          <p:cNvSpPr txBox="1"/>
          <p:nvPr/>
        </p:nvSpPr>
        <p:spPr>
          <a:xfrm>
            <a:off x="59025" y="45607"/>
            <a:ext cx="26664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3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9906549-68D3-4D0F-B867-84810EFCC5F4}"/>
              </a:ext>
            </a:extLst>
          </p:cNvPr>
          <p:cNvSpPr txBox="1"/>
          <p:nvPr/>
        </p:nvSpPr>
        <p:spPr>
          <a:xfrm>
            <a:off x="8665705" y="989860"/>
            <a:ext cx="10564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/>
              <a:t>p</a:t>
            </a:r>
            <a:r>
              <a:rPr lang="en-US" dirty="0"/>
              <a:t>= 0.3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4AADD4B-7E55-4373-A359-96655FD3EDF5}"/>
              </a:ext>
            </a:extLst>
          </p:cNvPr>
          <p:cNvSpPr txBox="1"/>
          <p:nvPr/>
        </p:nvSpPr>
        <p:spPr>
          <a:xfrm>
            <a:off x="2862403" y="4336262"/>
            <a:ext cx="10564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/>
              <a:t>p</a:t>
            </a:r>
            <a:r>
              <a:rPr lang="en-US" dirty="0"/>
              <a:t>= 0.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08FF2D4-0C88-4255-A31D-CB483EBA7F3D}"/>
              </a:ext>
            </a:extLst>
          </p:cNvPr>
          <p:cNvSpPr txBox="1"/>
          <p:nvPr/>
        </p:nvSpPr>
        <p:spPr>
          <a:xfrm rot="16200000">
            <a:off x="9852504" y="5732107"/>
            <a:ext cx="6425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n= 107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DEFA211-F25E-49CC-B1D1-FDC27B50F07B}"/>
              </a:ext>
            </a:extLst>
          </p:cNvPr>
          <p:cNvSpPr txBox="1"/>
          <p:nvPr/>
        </p:nvSpPr>
        <p:spPr>
          <a:xfrm rot="16200000">
            <a:off x="9852503" y="4994814"/>
            <a:ext cx="6425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n= 138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2F37C9C-42C6-48E4-BBAC-C7C7FD55030F}"/>
              </a:ext>
            </a:extLst>
          </p:cNvPr>
          <p:cNvSpPr txBox="1"/>
          <p:nvPr/>
        </p:nvSpPr>
        <p:spPr>
          <a:xfrm rot="16200000">
            <a:off x="7589289" y="5724907"/>
            <a:ext cx="6425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n= 82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1EF216A-3382-4177-AF8C-20CA1F99B1AB}"/>
              </a:ext>
            </a:extLst>
          </p:cNvPr>
          <p:cNvSpPr txBox="1"/>
          <p:nvPr/>
        </p:nvSpPr>
        <p:spPr>
          <a:xfrm rot="16200000">
            <a:off x="7589289" y="4994813"/>
            <a:ext cx="6425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n= 86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0C08242-5993-44B6-B626-2A4EF90E7A09}"/>
              </a:ext>
            </a:extLst>
          </p:cNvPr>
          <p:cNvSpPr txBox="1"/>
          <p:nvPr/>
        </p:nvSpPr>
        <p:spPr>
          <a:xfrm>
            <a:off x="7921309" y="4112828"/>
            <a:ext cx="10564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/>
              <a:t>p</a:t>
            </a:r>
            <a:r>
              <a:rPr lang="en-US" dirty="0"/>
              <a:t>= 0.3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0B2B57E-8440-480E-89DF-2AD112250246}"/>
              </a:ext>
            </a:extLst>
          </p:cNvPr>
          <p:cNvSpPr txBox="1"/>
          <p:nvPr/>
        </p:nvSpPr>
        <p:spPr>
          <a:xfrm>
            <a:off x="7163628" y="2707585"/>
            <a:ext cx="5643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(B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41BE274-8902-432C-BE4B-E40B420C349E}"/>
              </a:ext>
            </a:extLst>
          </p:cNvPr>
          <p:cNvSpPr txBox="1"/>
          <p:nvPr/>
        </p:nvSpPr>
        <p:spPr>
          <a:xfrm>
            <a:off x="1519595" y="6053046"/>
            <a:ext cx="55070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(C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2768807F-8B28-4079-96F7-CFA393CA51DC}"/>
              </a:ext>
            </a:extLst>
          </p:cNvPr>
          <p:cNvSpPr txBox="1"/>
          <p:nvPr/>
        </p:nvSpPr>
        <p:spPr>
          <a:xfrm>
            <a:off x="6871953" y="6053478"/>
            <a:ext cx="57822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(D)</a:t>
            </a:r>
          </a:p>
        </p:txBody>
      </p:sp>
      <p:graphicFrame>
        <p:nvGraphicFramePr>
          <p:cNvPr id="27" name="Object 26">
            <a:extLst>
              <a:ext uri="{FF2B5EF4-FFF2-40B4-BE49-F238E27FC236}">
                <a16:creationId xmlns:a16="http://schemas.microsoft.com/office/drawing/2014/main" id="{5B1289D9-28FC-4D18-B9B3-797995A2E8B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89419990"/>
              </p:ext>
            </p:extLst>
          </p:nvPr>
        </p:nvGraphicFramePr>
        <p:xfrm>
          <a:off x="1545592" y="714558"/>
          <a:ext cx="3377555" cy="26947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41" name="Prism 7" r:id="rId9" imgW="3827754" imgH="3052115" progId="Prism7.Document">
                  <p:embed/>
                </p:oleObj>
              </mc:Choice>
              <mc:Fallback>
                <p:oleObj name="Prism 7" r:id="rId9" imgW="3827754" imgH="3052115" progId="Prism7.Document">
                  <p:embed/>
                  <p:pic>
                    <p:nvPicPr>
                      <p:cNvPr id="27" name="Object 26">
                        <a:extLst>
                          <a:ext uri="{FF2B5EF4-FFF2-40B4-BE49-F238E27FC236}">
                            <a16:creationId xmlns:a16="http://schemas.microsoft.com/office/drawing/2014/main" id="{5B1289D9-28FC-4D18-B9B3-797995A2E8B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545592" y="714558"/>
                        <a:ext cx="3377555" cy="26947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8" name="TextBox 27">
            <a:extLst>
              <a:ext uri="{FF2B5EF4-FFF2-40B4-BE49-F238E27FC236}">
                <a16:creationId xmlns:a16="http://schemas.microsoft.com/office/drawing/2014/main" id="{472143C3-429F-400A-ABEA-BDAA29ED63E1}"/>
              </a:ext>
            </a:extLst>
          </p:cNvPr>
          <p:cNvSpPr txBox="1"/>
          <p:nvPr/>
        </p:nvSpPr>
        <p:spPr>
          <a:xfrm>
            <a:off x="2877626" y="966617"/>
            <a:ext cx="10564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/>
              <a:t>p</a:t>
            </a:r>
            <a:r>
              <a:rPr lang="en-US" dirty="0"/>
              <a:t>= 0.99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47D52AD-9D85-4F2B-A510-93DF900A4BEF}"/>
              </a:ext>
            </a:extLst>
          </p:cNvPr>
          <p:cNvSpPr txBox="1"/>
          <p:nvPr/>
        </p:nvSpPr>
        <p:spPr>
          <a:xfrm>
            <a:off x="1481240" y="2715571"/>
            <a:ext cx="58073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(A)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6F54481A-1FD5-4ED2-A8E5-006D876E0491}"/>
              </a:ext>
            </a:extLst>
          </p:cNvPr>
          <p:cNvSpPr txBox="1"/>
          <p:nvPr/>
        </p:nvSpPr>
        <p:spPr>
          <a:xfrm>
            <a:off x="2512563" y="2994505"/>
            <a:ext cx="6584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=168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98338CA-FC82-4C87-8796-345A0B35E678}"/>
              </a:ext>
            </a:extLst>
          </p:cNvPr>
          <p:cNvSpPr txBox="1"/>
          <p:nvPr/>
        </p:nvSpPr>
        <p:spPr>
          <a:xfrm>
            <a:off x="3554310" y="2990216"/>
            <a:ext cx="6584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=245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E3F58FE-6276-4E1B-984F-DC7458DD1986}"/>
              </a:ext>
            </a:extLst>
          </p:cNvPr>
          <p:cNvSpPr txBox="1"/>
          <p:nvPr/>
        </p:nvSpPr>
        <p:spPr>
          <a:xfrm>
            <a:off x="8218658" y="2969473"/>
            <a:ext cx="6584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=168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0D81B409-AF49-492D-AE4A-495B8D781236}"/>
              </a:ext>
            </a:extLst>
          </p:cNvPr>
          <p:cNvSpPr txBox="1"/>
          <p:nvPr/>
        </p:nvSpPr>
        <p:spPr>
          <a:xfrm>
            <a:off x="9260405" y="2965184"/>
            <a:ext cx="6584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=245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1579C904-8227-459F-A5D8-ED6ABC34E389}"/>
              </a:ext>
            </a:extLst>
          </p:cNvPr>
          <p:cNvSpPr txBox="1"/>
          <p:nvPr/>
        </p:nvSpPr>
        <p:spPr>
          <a:xfrm>
            <a:off x="2561154" y="6313180"/>
            <a:ext cx="6584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=168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96ABB134-2090-4505-8F50-A816EE9D85EA}"/>
              </a:ext>
            </a:extLst>
          </p:cNvPr>
          <p:cNvSpPr txBox="1"/>
          <p:nvPr/>
        </p:nvSpPr>
        <p:spPr>
          <a:xfrm>
            <a:off x="3602901" y="6308891"/>
            <a:ext cx="6584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=245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F352A98B-1FE8-45EA-BDFA-15168B59FEC5}"/>
              </a:ext>
            </a:extLst>
          </p:cNvPr>
          <p:cNvSpPr txBox="1"/>
          <p:nvPr/>
        </p:nvSpPr>
        <p:spPr>
          <a:xfrm>
            <a:off x="8179961" y="6315679"/>
            <a:ext cx="6584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=168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DEF879F0-68B5-4027-912B-21DA97BC987C}"/>
              </a:ext>
            </a:extLst>
          </p:cNvPr>
          <p:cNvSpPr txBox="1"/>
          <p:nvPr/>
        </p:nvSpPr>
        <p:spPr>
          <a:xfrm>
            <a:off x="9417019" y="6311390"/>
            <a:ext cx="6584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=245</a:t>
            </a:r>
          </a:p>
        </p:txBody>
      </p:sp>
    </p:spTree>
    <p:extLst>
      <p:ext uri="{BB962C8B-B14F-4D97-AF65-F5344CB8AC3E}">
        <p14:creationId xmlns:p14="http://schemas.microsoft.com/office/powerpoint/2010/main" val="37746751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E481F8F7-D778-426A-87E5-2B143E619AB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93954562"/>
              </p:ext>
            </p:extLst>
          </p:nvPr>
        </p:nvGraphicFramePr>
        <p:xfrm>
          <a:off x="412750" y="906463"/>
          <a:ext cx="11125200" cy="4959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08" name="Prism 7" r:id="rId3" imgW="7703022" imgH="3433314" progId="Prism7.Document">
                  <p:embed/>
                </p:oleObj>
              </mc:Choice>
              <mc:Fallback>
                <p:oleObj name="Prism 7" r:id="rId3" imgW="7703022" imgH="3433314" progId="Prism7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E481F8F7-D778-426A-87E5-2B143E619AB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12750" y="906463"/>
                        <a:ext cx="11125200" cy="49593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3902600C-839A-4AA3-8056-8553F3C1F4B4}"/>
              </a:ext>
            </a:extLst>
          </p:cNvPr>
          <p:cNvSpPr txBox="1"/>
          <p:nvPr/>
        </p:nvSpPr>
        <p:spPr>
          <a:xfrm>
            <a:off x="67903" y="0"/>
            <a:ext cx="27108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4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0AFD8FB-24B9-49DF-91C0-5C06A8CD25E8}"/>
              </a:ext>
            </a:extLst>
          </p:cNvPr>
          <p:cNvSpPr txBox="1"/>
          <p:nvPr/>
        </p:nvSpPr>
        <p:spPr>
          <a:xfrm>
            <a:off x="5410329" y="1353147"/>
            <a:ext cx="9991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i="1" dirty="0"/>
              <a:t>p </a:t>
            </a:r>
            <a:r>
              <a:rPr lang="en-US" b="1" dirty="0"/>
              <a:t>&gt; 0.05</a:t>
            </a:r>
          </a:p>
        </p:txBody>
      </p:sp>
    </p:spTree>
    <p:extLst>
      <p:ext uri="{BB962C8B-B14F-4D97-AF65-F5344CB8AC3E}">
        <p14:creationId xmlns:p14="http://schemas.microsoft.com/office/powerpoint/2010/main" val="321727685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AFDF89C6-10CE-401C-80BF-C301EC46227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33276920"/>
              </p:ext>
            </p:extLst>
          </p:nvPr>
        </p:nvGraphicFramePr>
        <p:xfrm>
          <a:off x="461963" y="719138"/>
          <a:ext cx="11449050" cy="6375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33" name="Prism 7" r:id="rId3" imgW="9325696" imgH="5193166" progId="Prism7.Document">
                  <p:embed/>
                </p:oleObj>
              </mc:Choice>
              <mc:Fallback>
                <p:oleObj name="Prism 7" r:id="rId3" imgW="9325696" imgH="5193166" progId="Prism7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AFDF89C6-10CE-401C-80BF-C301EC46227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61963" y="719138"/>
                        <a:ext cx="11449050" cy="6375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C553F5FB-287C-43F9-B985-F7A338690D93}"/>
              </a:ext>
            </a:extLst>
          </p:cNvPr>
          <p:cNvSpPr txBox="1"/>
          <p:nvPr/>
        </p:nvSpPr>
        <p:spPr>
          <a:xfrm>
            <a:off x="59026" y="45607"/>
            <a:ext cx="26752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5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BC5ACBA-D77F-4F70-91B1-C60F40206CAB}"/>
              </a:ext>
            </a:extLst>
          </p:cNvPr>
          <p:cNvSpPr txBox="1"/>
          <p:nvPr/>
        </p:nvSpPr>
        <p:spPr>
          <a:xfrm>
            <a:off x="5951867" y="1148960"/>
            <a:ext cx="9991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i="1" dirty="0"/>
              <a:t>p </a:t>
            </a:r>
            <a:r>
              <a:rPr lang="en-US" b="1" dirty="0"/>
              <a:t>&gt; 0.05</a:t>
            </a:r>
          </a:p>
        </p:txBody>
      </p:sp>
    </p:spTree>
    <p:extLst>
      <p:ext uri="{BB962C8B-B14F-4D97-AF65-F5344CB8AC3E}">
        <p14:creationId xmlns:p14="http://schemas.microsoft.com/office/powerpoint/2010/main" val="17646139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4D19C417-3984-4EBB-8EB8-DBE04E274F0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81081849"/>
              </p:ext>
            </p:extLst>
          </p:nvPr>
        </p:nvGraphicFramePr>
        <p:xfrm>
          <a:off x="3276600" y="490538"/>
          <a:ext cx="2778125" cy="23352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305" name="Prism 7" r:id="rId3" imgW="3497316" imgH="2938007" progId="Prism7.Document">
                  <p:embed/>
                </p:oleObj>
              </mc:Choice>
              <mc:Fallback>
                <p:oleObj name="Prism 7" r:id="rId3" imgW="3497316" imgH="2938007" progId="Prism7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4D19C417-3984-4EBB-8EB8-DBE04E274F0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276600" y="490538"/>
                        <a:ext cx="2778125" cy="23352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DF46652D-3986-42C3-B8D1-62CA1D4C5F03}"/>
              </a:ext>
            </a:extLst>
          </p:cNvPr>
          <p:cNvCxnSpPr/>
          <p:nvPr/>
        </p:nvCxnSpPr>
        <p:spPr>
          <a:xfrm>
            <a:off x="639196" y="2627797"/>
            <a:ext cx="1076861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F4FC1E4C-556E-4457-8321-73024C13D5AC}"/>
              </a:ext>
            </a:extLst>
          </p:cNvPr>
          <p:cNvCxnSpPr/>
          <p:nvPr/>
        </p:nvCxnSpPr>
        <p:spPr>
          <a:xfrm>
            <a:off x="639196" y="2664782"/>
            <a:ext cx="1076861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AE4F363C-2FA4-4C01-A420-AC8A2EF597C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4199611"/>
              </p:ext>
            </p:extLst>
          </p:nvPr>
        </p:nvGraphicFramePr>
        <p:xfrm>
          <a:off x="5880100" y="488950"/>
          <a:ext cx="2840038" cy="2339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306" name="Prism 7" r:id="rId5" imgW="3573266" imgH="2945566" progId="Prism7.Document">
                  <p:embed/>
                </p:oleObj>
              </mc:Choice>
              <mc:Fallback>
                <p:oleObj name="Prism 7" r:id="rId5" imgW="3573266" imgH="2945566" progId="Prism7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AE4F363C-2FA4-4C01-A420-AC8A2EF597C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880100" y="488950"/>
                        <a:ext cx="2840038" cy="2339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67A83C85-7CB0-45FF-A417-2B86916B693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07481477"/>
              </p:ext>
            </p:extLst>
          </p:nvPr>
        </p:nvGraphicFramePr>
        <p:xfrm>
          <a:off x="1674813" y="2728913"/>
          <a:ext cx="2778125" cy="2339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307" name="Prism 7" r:id="rId7" imgW="3497316" imgH="2945566" progId="Prism7.Document">
                  <p:embed/>
                </p:oleObj>
              </mc:Choice>
              <mc:Fallback>
                <p:oleObj name="Prism 7" r:id="rId7" imgW="3497316" imgH="2945566" progId="Prism7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67A83C85-7CB0-45FF-A417-2B86916B693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674813" y="2728913"/>
                        <a:ext cx="2778125" cy="2339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84368556-E5AE-457A-8B57-772855BE97D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60993472"/>
              </p:ext>
            </p:extLst>
          </p:nvPr>
        </p:nvGraphicFramePr>
        <p:xfrm>
          <a:off x="4665663" y="2728913"/>
          <a:ext cx="2711450" cy="2339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308" name="Prism 7" r:id="rId9" imgW="3413446" imgH="2945566" progId="Prism7.Document">
                  <p:embed/>
                </p:oleObj>
              </mc:Choice>
              <mc:Fallback>
                <p:oleObj name="Prism 7" r:id="rId9" imgW="3413446" imgH="2945566" progId="Prism7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84368556-E5AE-457A-8B57-772855BE97D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665663" y="2728913"/>
                        <a:ext cx="2711450" cy="2339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387D3084-B752-4E84-94C8-EA3CD931C2F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60545341"/>
              </p:ext>
            </p:extLst>
          </p:nvPr>
        </p:nvGraphicFramePr>
        <p:xfrm>
          <a:off x="7589838" y="2728913"/>
          <a:ext cx="2771775" cy="2339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309" name="Prism 7" r:id="rId11" imgW="3489397" imgH="2945566" progId="Prism7.Document">
                  <p:embed/>
                </p:oleObj>
              </mc:Choice>
              <mc:Fallback>
                <p:oleObj name="Prism 7" r:id="rId11" imgW="3489397" imgH="2945566" progId="Prism7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387D3084-B752-4E84-94C8-EA3CD931C2F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7589838" y="2728913"/>
                        <a:ext cx="2771775" cy="2339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5879BAEE-BA1A-4AC7-A2BC-1D7521150ED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7094368"/>
              </p:ext>
            </p:extLst>
          </p:nvPr>
        </p:nvGraphicFramePr>
        <p:xfrm>
          <a:off x="563563" y="4799013"/>
          <a:ext cx="2713037" cy="2339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310" name="Prism 7" r:id="rId13" imgW="3413446" imgH="2945566" progId="Prism7.Document">
                  <p:embed/>
                </p:oleObj>
              </mc:Choice>
              <mc:Fallback>
                <p:oleObj name="Prism 7" r:id="rId13" imgW="3413446" imgH="2945566" progId="Prism7.Document">
                  <p:embed/>
                  <p:pic>
                    <p:nvPicPr>
                      <p:cNvPr id="14" name="Object 13">
                        <a:extLst>
                          <a:ext uri="{FF2B5EF4-FFF2-40B4-BE49-F238E27FC236}">
                            <a16:creationId xmlns:a16="http://schemas.microsoft.com/office/drawing/2014/main" id="{5879BAEE-BA1A-4AC7-A2BC-1D7521150ED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563563" y="4799013"/>
                        <a:ext cx="2713037" cy="2339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D1E55B59-C9E2-489C-BCB0-1F1CE876DB9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66548004"/>
              </p:ext>
            </p:extLst>
          </p:nvPr>
        </p:nvGraphicFramePr>
        <p:xfrm>
          <a:off x="3276600" y="4835525"/>
          <a:ext cx="2771775" cy="2339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311" name="Prism 7" r:id="rId15" imgW="3489397" imgH="2945566" progId="Prism7.Document">
                  <p:embed/>
                </p:oleObj>
              </mc:Choice>
              <mc:Fallback>
                <p:oleObj name="Prism 7" r:id="rId15" imgW="3489397" imgH="2945566" progId="Prism7.Document">
                  <p:embed/>
                  <p:pic>
                    <p:nvPicPr>
                      <p:cNvPr id="15" name="Object 14">
                        <a:extLst>
                          <a:ext uri="{FF2B5EF4-FFF2-40B4-BE49-F238E27FC236}">
                            <a16:creationId xmlns:a16="http://schemas.microsoft.com/office/drawing/2014/main" id="{D1E55B59-C9E2-489C-BCB0-1F1CE876DB9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3276600" y="4835525"/>
                        <a:ext cx="2771775" cy="2339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AE51B159-012F-47C6-95FE-A6BE3FD689F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78994831"/>
              </p:ext>
            </p:extLst>
          </p:nvPr>
        </p:nvGraphicFramePr>
        <p:xfrm>
          <a:off x="6048375" y="4799013"/>
          <a:ext cx="2773363" cy="2339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312" name="Prism 7" r:id="rId17" imgW="3489397" imgH="2945566" progId="Prism7.Document">
                  <p:embed/>
                </p:oleObj>
              </mc:Choice>
              <mc:Fallback>
                <p:oleObj name="Prism 7" r:id="rId17" imgW="3489397" imgH="2945566" progId="Prism7.Document">
                  <p:embed/>
                  <p:pic>
                    <p:nvPicPr>
                      <p:cNvPr id="16" name="Object 15">
                        <a:extLst>
                          <a:ext uri="{FF2B5EF4-FFF2-40B4-BE49-F238E27FC236}">
                            <a16:creationId xmlns:a16="http://schemas.microsoft.com/office/drawing/2014/main" id="{AE51B159-012F-47C6-95FE-A6BE3FD689F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6048375" y="4799013"/>
                        <a:ext cx="2773363" cy="2339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>
            <a:extLst>
              <a:ext uri="{FF2B5EF4-FFF2-40B4-BE49-F238E27FC236}">
                <a16:creationId xmlns:a16="http://schemas.microsoft.com/office/drawing/2014/main" id="{BD5A0447-AA91-4B9D-9002-88786AAC592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56778379"/>
              </p:ext>
            </p:extLst>
          </p:nvPr>
        </p:nvGraphicFramePr>
        <p:xfrm>
          <a:off x="8729663" y="4799013"/>
          <a:ext cx="2840037" cy="2339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313" name="Prism 7" r:id="rId19" imgW="3573266" imgH="2945566" progId="Prism7.Document">
                  <p:embed/>
                </p:oleObj>
              </mc:Choice>
              <mc:Fallback>
                <p:oleObj name="Prism 7" r:id="rId19" imgW="3573266" imgH="2945566" progId="Prism7.Document">
                  <p:embed/>
                  <p:pic>
                    <p:nvPicPr>
                      <p:cNvPr id="17" name="Object 16">
                        <a:extLst>
                          <a:ext uri="{FF2B5EF4-FFF2-40B4-BE49-F238E27FC236}">
                            <a16:creationId xmlns:a16="http://schemas.microsoft.com/office/drawing/2014/main" id="{BD5A0447-AA91-4B9D-9002-88786AAC592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8729663" y="4799013"/>
                        <a:ext cx="2840037" cy="2339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8" name="TextBox 17">
            <a:extLst>
              <a:ext uri="{FF2B5EF4-FFF2-40B4-BE49-F238E27FC236}">
                <a16:creationId xmlns:a16="http://schemas.microsoft.com/office/drawing/2014/main" id="{EA7B7744-7362-4AC4-B261-8EAF13653BBA}"/>
              </a:ext>
            </a:extLst>
          </p:cNvPr>
          <p:cNvSpPr txBox="1"/>
          <p:nvPr/>
        </p:nvSpPr>
        <p:spPr>
          <a:xfrm rot="16200000">
            <a:off x="-558598" y="1436408"/>
            <a:ext cx="181812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levated in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s2065418 TT high ISS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14EC442-9957-47A6-865D-79FE0EE8C1AB}"/>
              </a:ext>
            </a:extLst>
          </p:cNvPr>
          <p:cNvSpPr txBox="1"/>
          <p:nvPr/>
        </p:nvSpPr>
        <p:spPr>
          <a:xfrm rot="16200000">
            <a:off x="-558599" y="4480947"/>
            <a:ext cx="181812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Lowered in 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s2065418 TT high ISS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2B3803F-7654-41DA-9664-AD69C79BD300}"/>
              </a:ext>
            </a:extLst>
          </p:cNvPr>
          <p:cNvSpPr txBox="1"/>
          <p:nvPr/>
        </p:nvSpPr>
        <p:spPr>
          <a:xfrm>
            <a:off x="59025" y="45607"/>
            <a:ext cx="26664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6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1FF3019-3613-4869-9201-A636753353CB}"/>
              </a:ext>
            </a:extLst>
          </p:cNvPr>
          <p:cNvSpPr txBox="1"/>
          <p:nvPr/>
        </p:nvSpPr>
        <p:spPr>
          <a:xfrm>
            <a:off x="4341178" y="696033"/>
            <a:ext cx="12162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dirty="0"/>
              <a:t>p</a:t>
            </a:r>
            <a:r>
              <a:rPr lang="en-US" sz="1200" b="1" dirty="0"/>
              <a:t>-value = 0.003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8FCAC8D-913D-42A3-8840-AD241F8021D2}"/>
              </a:ext>
            </a:extLst>
          </p:cNvPr>
          <p:cNvSpPr txBox="1"/>
          <p:nvPr/>
        </p:nvSpPr>
        <p:spPr>
          <a:xfrm>
            <a:off x="6993459" y="696033"/>
            <a:ext cx="13126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dirty="0"/>
              <a:t>p</a:t>
            </a:r>
            <a:r>
              <a:rPr lang="en-US" sz="1200" b="1" dirty="0"/>
              <a:t>-value = 0.0003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0CE7FD5-E6B2-43D3-B279-CDB60F5FBD0A}"/>
              </a:ext>
            </a:extLst>
          </p:cNvPr>
          <p:cNvSpPr txBox="1"/>
          <p:nvPr/>
        </p:nvSpPr>
        <p:spPr>
          <a:xfrm>
            <a:off x="2752078" y="2937445"/>
            <a:ext cx="12162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dirty="0"/>
              <a:t>p</a:t>
            </a:r>
            <a:r>
              <a:rPr lang="en-US" sz="1200" b="1" dirty="0"/>
              <a:t>-value = 0.007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7C43950-4EEC-49D8-926A-83291DE7F950}"/>
              </a:ext>
            </a:extLst>
          </p:cNvPr>
          <p:cNvSpPr txBox="1"/>
          <p:nvPr/>
        </p:nvSpPr>
        <p:spPr>
          <a:xfrm>
            <a:off x="5712382" y="2940802"/>
            <a:ext cx="12162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dirty="0"/>
              <a:t>p</a:t>
            </a:r>
            <a:r>
              <a:rPr lang="en-US" sz="1200" b="1" dirty="0"/>
              <a:t>-value = 0.008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E872A552-C78F-4187-BB71-844F1C64BCD1}"/>
              </a:ext>
            </a:extLst>
          </p:cNvPr>
          <p:cNvSpPr txBox="1"/>
          <p:nvPr/>
        </p:nvSpPr>
        <p:spPr>
          <a:xfrm>
            <a:off x="8652371" y="2937445"/>
            <a:ext cx="12162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dirty="0"/>
              <a:t>p</a:t>
            </a:r>
            <a:r>
              <a:rPr lang="en-US" sz="1200" b="1" dirty="0"/>
              <a:t>-value = 0.001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B30F5F3-F5C9-4982-9D5B-FA3DD3F558B1}"/>
              </a:ext>
            </a:extLst>
          </p:cNvPr>
          <p:cNvSpPr txBox="1"/>
          <p:nvPr/>
        </p:nvSpPr>
        <p:spPr>
          <a:xfrm>
            <a:off x="1562471" y="5009607"/>
            <a:ext cx="1290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dirty="0"/>
              <a:t>p</a:t>
            </a:r>
            <a:r>
              <a:rPr lang="en-US" sz="1200" b="1" dirty="0"/>
              <a:t>-value &lt; 0.0001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544432F-C7E9-4D62-9333-37BFDEBFE091}"/>
              </a:ext>
            </a:extLst>
          </p:cNvPr>
          <p:cNvSpPr txBox="1"/>
          <p:nvPr/>
        </p:nvSpPr>
        <p:spPr>
          <a:xfrm>
            <a:off x="4300578" y="5038796"/>
            <a:ext cx="12162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dirty="0"/>
              <a:t>p</a:t>
            </a:r>
            <a:r>
              <a:rPr lang="en-US" sz="1200" b="1" dirty="0"/>
              <a:t>-value = 0.007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150AC66-CB7C-4D32-AF68-526541B726BD}"/>
              </a:ext>
            </a:extLst>
          </p:cNvPr>
          <p:cNvSpPr txBox="1"/>
          <p:nvPr/>
        </p:nvSpPr>
        <p:spPr>
          <a:xfrm>
            <a:off x="7089836" y="5012162"/>
            <a:ext cx="12947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dirty="0"/>
              <a:t>p</a:t>
            </a:r>
            <a:r>
              <a:rPr lang="en-US" sz="1200" b="1" dirty="0"/>
              <a:t>-value &lt; 0.0001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65C485B-CB5B-4C2A-BF2C-305AFF51A5DC}"/>
              </a:ext>
            </a:extLst>
          </p:cNvPr>
          <p:cNvSpPr txBox="1"/>
          <p:nvPr/>
        </p:nvSpPr>
        <p:spPr>
          <a:xfrm>
            <a:off x="9829164" y="5015810"/>
            <a:ext cx="12162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dirty="0"/>
              <a:t>p</a:t>
            </a:r>
            <a:r>
              <a:rPr lang="en-US" sz="1200" b="1" dirty="0"/>
              <a:t>-value = 0.007</a:t>
            </a:r>
          </a:p>
        </p:txBody>
      </p:sp>
    </p:spTree>
    <p:extLst>
      <p:ext uri="{BB962C8B-B14F-4D97-AF65-F5344CB8AC3E}">
        <p14:creationId xmlns:p14="http://schemas.microsoft.com/office/powerpoint/2010/main" val="374076669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70E2E2D8-5333-4AE8-8A6C-5DE57C1AC246}"/>
              </a:ext>
            </a:extLst>
          </p:cNvPr>
          <p:cNvSpPr txBox="1"/>
          <p:nvPr/>
        </p:nvSpPr>
        <p:spPr>
          <a:xfrm>
            <a:off x="2541152" y="430383"/>
            <a:ext cx="253013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Control</a:t>
            </a:r>
          </a:p>
        </p:txBody>
      </p:sp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244EBC15-806A-4EC6-BB28-1C2503323D7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1018555"/>
              </p:ext>
            </p:extLst>
          </p:nvPr>
        </p:nvGraphicFramePr>
        <p:xfrm>
          <a:off x="58738" y="1138238"/>
          <a:ext cx="6129337" cy="5102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14" name="Prism 7" r:id="rId3" imgW="6762821" imgH="5627640" progId="Prism7.Document">
                  <p:embed/>
                </p:oleObj>
              </mc:Choice>
              <mc:Fallback>
                <p:oleObj name="Prism 7" r:id="rId3" imgW="6762821" imgH="5627640" progId="Prism7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244EBC15-806A-4EC6-BB28-1C2503323D7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8738" y="1138238"/>
                        <a:ext cx="6129337" cy="5102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902FD701-16A8-45EC-85B8-0826DEF7D27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25848927"/>
              </p:ext>
            </p:extLst>
          </p:nvPr>
        </p:nvGraphicFramePr>
        <p:xfrm>
          <a:off x="6276975" y="1138238"/>
          <a:ext cx="5946775" cy="5102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15" name="Prism 7" r:id="rId5" imgW="6392428" imgH="5485815" progId="Prism7.Document">
                  <p:embed/>
                </p:oleObj>
              </mc:Choice>
              <mc:Fallback>
                <p:oleObj name="Prism 7" r:id="rId5" imgW="6392428" imgH="5485815" progId="Prism7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902FD701-16A8-45EC-85B8-0826DEF7D27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276975" y="1138238"/>
                        <a:ext cx="5946775" cy="5102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TextBox 11">
            <a:extLst>
              <a:ext uri="{FF2B5EF4-FFF2-40B4-BE49-F238E27FC236}">
                <a16:creationId xmlns:a16="http://schemas.microsoft.com/office/drawing/2014/main" id="{2BD31D8F-FB73-4602-AF4E-1B3A94E30E69}"/>
              </a:ext>
            </a:extLst>
          </p:cNvPr>
          <p:cNvSpPr txBox="1"/>
          <p:nvPr/>
        </p:nvSpPr>
        <p:spPr>
          <a:xfrm>
            <a:off x="7399032" y="435234"/>
            <a:ext cx="353183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rs2065418 TT high ISS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BEE8DBCC-C8CF-4E74-A8FC-831168FB259B}"/>
              </a:ext>
            </a:extLst>
          </p:cNvPr>
          <p:cNvSpPr/>
          <p:nvPr/>
        </p:nvSpPr>
        <p:spPr>
          <a:xfrm>
            <a:off x="319597" y="1358283"/>
            <a:ext cx="5110820" cy="1118586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40C05863-77D2-4BCE-9CB5-1374948B0D1C}"/>
              </a:ext>
            </a:extLst>
          </p:cNvPr>
          <p:cNvSpPr/>
          <p:nvPr/>
        </p:nvSpPr>
        <p:spPr>
          <a:xfrm>
            <a:off x="6566094" y="1371688"/>
            <a:ext cx="4895008" cy="1105181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F0B1208-7E59-4E8C-9982-55AB4BC06879}"/>
              </a:ext>
            </a:extLst>
          </p:cNvPr>
          <p:cNvSpPr txBox="1"/>
          <p:nvPr/>
        </p:nvSpPr>
        <p:spPr>
          <a:xfrm>
            <a:off x="59025" y="45607"/>
            <a:ext cx="26664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7</a:t>
            </a:r>
          </a:p>
        </p:txBody>
      </p:sp>
    </p:spTree>
    <p:extLst>
      <p:ext uri="{BB962C8B-B14F-4D97-AF65-F5344CB8AC3E}">
        <p14:creationId xmlns:p14="http://schemas.microsoft.com/office/powerpoint/2010/main" val="24254707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47</Words>
  <Application>Microsoft Office PowerPoint</Application>
  <PresentationFormat>Widescreen</PresentationFormat>
  <Paragraphs>82</Paragraphs>
  <Slides>7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7</vt:i4>
      </vt:variant>
    </vt:vector>
  </HeadingPairs>
  <TitlesOfParts>
    <vt:vector size="13" baseType="lpstr">
      <vt:lpstr>Arial</vt:lpstr>
      <vt:lpstr>Calibri</vt:lpstr>
      <vt:lpstr>Calibri Light</vt:lpstr>
      <vt:lpstr>Office Theme</vt:lpstr>
      <vt:lpstr>Prism 7</vt:lpstr>
      <vt:lpstr>GraphPad Prism 7 Projec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ukas Schimunek</dc:creator>
  <cp:lastModifiedBy>Lukas Schimunek</cp:lastModifiedBy>
  <cp:revision>41</cp:revision>
  <dcterms:created xsi:type="dcterms:W3CDTF">2017-11-07T18:11:01Z</dcterms:created>
  <dcterms:modified xsi:type="dcterms:W3CDTF">2019-06-03T19:11:09Z</dcterms:modified>
</cp:coreProperties>
</file>